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B114A1-0279-4DF8-9CA5-001857F0D170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DC5D12-EE3B-4672-93F2-D4F1DC0A2DA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Additional</a:t>
            </a:r>
            <a:r>
              <a:rPr lang="en-US" baseline="0" dirty="0" smtClean="0"/>
              <a:t> File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B5B651-E703-4C3C-8C0A-8E499028DCEB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351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A4B56-1763-4CB7-BCCA-6CA4F6057692}" type="datetimeFigureOut">
              <a:rPr lang="en-US" smtClean="0"/>
              <a:t>10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9EA32-EA4F-4679-8BB8-4BF0179AFF8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004417527"/>
              </p:ext>
            </p:extLst>
          </p:nvPr>
        </p:nvGraphicFramePr>
        <p:xfrm>
          <a:off x="152400" y="1752600"/>
          <a:ext cx="8839200" cy="950835"/>
        </p:xfrm>
        <a:graphic>
          <a:graphicData uri="http://schemas.openxmlformats.org/drawingml/2006/table">
            <a:tbl>
              <a:tblPr firstRow="1">
                <a:tableStyleId>{5940675A-B579-460E-94D1-54222C63F5DA}</a:tableStyleId>
              </a:tblPr>
              <a:tblGrid>
                <a:gridCol w="1600200"/>
                <a:gridCol w="1066800"/>
                <a:gridCol w="1219200"/>
                <a:gridCol w="1456042"/>
                <a:gridCol w="1591958"/>
                <a:gridCol w="838200"/>
                <a:gridCol w="1066800"/>
              </a:tblGrid>
              <a:tr h="153030"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Plantaris (mg)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Plantaris </a:t>
                      </a:r>
                      <a:r>
                        <a:rPr lang="en-US" sz="1200" b="1" u="none" strike="noStrike" dirty="0" smtClean="0">
                          <a:effectLst/>
                        </a:rPr>
                        <a:t>(mg/g</a:t>
                      </a:r>
                      <a:r>
                        <a:rPr lang="en-US" sz="1200" b="1" u="none" strike="noStrike" dirty="0">
                          <a:effectLst/>
                        </a:rPr>
                        <a:t>)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Gastrocnemius (mg)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Gastrocnemius (mg/g)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</a:rPr>
                        <a:t>Soleus (</a:t>
                      </a:r>
                      <a:r>
                        <a:rPr lang="en-US" sz="1200" b="1" u="none" strike="noStrike" dirty="0">
                          <a:effectLst/>
                        </a:rPr>
                        <a:t>mg)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effectLst/>
                        </a:rPr>
                        <a:t>Soleus (</a:t>
                      </a:r>
                      <a:r>
                        <a:rPr lang="en-US" sz="1200" b="1" u="none" strike="noStrike" dirty="0">
                          <a:effectLst/>
                        </a:rPr>
                        <a:t>mg/g)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30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Ambulatory Vehic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6.21 ± 0.7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56 ± 0.0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5.68 ± 3.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</a:rPr>
                        <a:t>4.00 </a:t>
                      </a:r>
                      <a:r>
                        <a:rPr lang="en-US" sz="1200" u="none" strike="noStrike" dirty="0">
                          <a:effectLst/>
                        </a:rPr>
                        <a:t>± 0.1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.79 ± 0.4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266 ± 0.0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</a:tr>
              <a:tr h="1530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Ambulatory Tamoxifen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6.80 ± 1.6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64 ± 0.08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3.91 ± 2.5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56 ± 0.04 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smtClean="0">
                          <a:effectLst/>
                        </a:rPr>
                        <a:t> 6.62 </a:t>
                      </a:r>
                      <a:r>
                        <a:rPr lang="en-US" sz="1200" u="none" strike="noStrike" dirty="0">
                          <a:effectLst/>
                        </a:rPr>
                        <a:t>± </a:t>
                      </a:r>
                      <a:r>
                        <a:rPr lang="en-US" sz="1200" u="none" strike="noStrike" dirty="0" smtClean="0">
                          <a:effectLst/>
                        </a:rPr>
                        <a:t>0.37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249 ± 0.02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</a:tr>
              <a:tr h="1530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Running Vehic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5.15 ±0.7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59 ± 0.03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08.02± 2.6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24 ± 0.1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8.31 ± 0.3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325 </a:t>
                      </a:r>
                      <a:r>
                        <a:rPr lang="en-US" sz="1200" u="none" strike="noStrike" dirty="0" smtClean="0">
                          <a:effectLst/>
                        </a:rPr>
                        <a:t>± 0.0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</a:tr>
              <a:tr h="1530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Running Tamoxifen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4.83 ±0.83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60 ± 0.03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04.69 ± 1.9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25 ± 0.08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.55 ± 0.36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306 </a:t>
                      </a:r>
                      <a:r>
                        <a:rPr lang="en-US" sz="1200" u="none" strike="noStrike" dirty="0" smtClean="0">
                          <a:effectLst/>
                        </a:rPr>
                        <a:t>± 0.01</a:t>
                      </a:r>
                      <a:endParaRPr lang="en-US" sz="12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7287" marR="7287" marT="7287" marB="0" anchor="b"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On-screen Show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&amp;J</dc:creator>
  <cp:lastModifiedBy>J&amp;J</cp:lastModifiedBy>
  <cp:revision>1</cp:revision>
  <dcterms:created xsi:type="dcterms:W3CDTF">2015-10-12T15:19:19Z</dcterms:created>
  <dcterms:modified xsi:type="dcterms:W3CDTF">2015-10-12T15:19:39Z</dcterms:modified>
</cp:coreProperties>
</file>